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hDuBsja8uxCgQhB8y0ihIws5vKV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2EA3DB22-7D82-4B43-8A66-9A3671CCD8C3}">
  <a:tblStyle styleId="{2EA3DB22-7D82-4B43-8A66-9A3671CCD8C3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slide" Target="slides/slide2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4" Type="http://schemas.openxmlformats.org/officeDocument/2006/relationships/notesMaster" Target="notesMasters/notes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4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T"/>
              <a:t>‹N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4" name="Google Shape;84;p1"/>
          <p:cNvGraphicFramePr/>
          <p:nvPr>
            <p:extLst>
              <p:ext uri="{D42A27DB-BD31-4B8C-83A1-F6EECF244321}">
                <p14:modId xmlns:p14="http://schemas.microsoft.com/office/powerpoint/2010/main" val="455383088"/>
              </p:ext>
            </p:extLst>
          </p:nvPr>
        </p:nvGraphicFramePr>
        <p:xfrm>
          <a:off x="838200" y="2689439"/>
          <a:ext cx="10515600" cy="1441450"/>
        </p:xfrm>
        <a:graphic>
          <a:graphicData uri="http://schemas.openxmlformats.org/drawingml/2006/table">
            <a:tbl>
              <a:tblPr>
                <a:noFill/>
                <a:tableStyleId>{2EA3DB22-7D82-4B43-8A66-9A3671CCD8C3}</a:tableStyleId>
              </a:tblPr>
              <a:tblGrid>
                <a:gridCol w="17526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52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52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526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526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7526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4254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i="0" u="none" strike="noStrike" cap="none" dirty="0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Bc</a:t>
                      </a:r>
                      <a:r>
                        <a:rPr lang="en-IT" sz="1050" b="1" u="none" strike="noStrike" cap="none" dirty="0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alB</a:t>
                      </a:r>
                      <a:endParaRPr sz="12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 dirty="0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urification step</a:t>
                      </a:r>
                      <a:endParaRPr sz="12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otal protein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 (mg)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otal activity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(U)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ecific activity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(U/mg)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urification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fold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Yield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b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(%)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ellular extract not transformed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8.44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422.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0.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/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/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ellular extract not induced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7.7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615.2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3.4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/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/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ellular extract induced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09.4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52978.2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53.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.0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ffinity chromatography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0.3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3550.2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229.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6.72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1050" u="none" strike="noStrike" cap="none" dirty="0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2.2</a:t>
                      </a:r>
                      <a:endParaRPr sz="12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0" marR="0" marT="0" marB="63500" anchor="b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85" name="Google Shape;85;p1"/>
          <p:cNvSpPr/>
          <p:nvPr/>
        </p:nvSpPr>
        <p:spPr>
          <a:xfrm>
            <a:off x="3500582" y="4398743"/>
            <a:ext cx="409152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IT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upplementary Table 1. </a:t>
            </a:r>
            <a:r>
              <a:rPr lang="en-IT" sz="12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Purification table of BcGalB</a:t>
            </a:r>
            <a:r>
              <a:rPr lang="en-IT" sz="9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.</a:t>
            </a:r>
            <a:endParaRPr sz="9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0" name="Google Shape;90;p2"/>
          <p:cNvGraphicFramePr/>
          <p:nvPr/>
        </p:nvGraphicFramePr>
        <p:xfrm>
          <a:off x="4110102" y="2054875"/>
          <a:ext cx="3971800" cy="2038975"/>
        </p:xfrm>
        <a:graphic>
          <a:graphicData uri="http://schemas.openxmlformats.org/drawingml/2006/table">
            <a:tbl>
              <a:tblPr>
                <a:noFill/>
                <a:tableStyleId>{2EA3DB22-7D82-4B43-8A66-9A3671CCD8C3}</a:tableStyleId>
              </a:tblPr>
              <a:tblGrid>
                <a:gridCol w="19859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859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ompound (50 mM)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b="1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Relative activity (%)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DS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7.9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ween 20 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65.7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β-mercaptoethanol 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6.2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DTT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64.5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rea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9.0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59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uanidine chloride 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IT" sz="900" u="none" strike="noStrike" cap="non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3.1</a:t>
                      </a:r>
                      <a:endParaRPr sz="12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88900" marR="88900" marT="50800" marB="50800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91" name="Google Shape;91;p2"/>
          <p:cNvSpPr/>
          <p:nvPr/>
        </p:nvSpPr>
        <p:spPr>
          <a:xfrm>
            <a:off x="3556000" y="4199477"/>
            <a:ext cx="5172363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IT" sz="1200" b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upplementary Table 2. </a:t>
            </a:r>
            <a:r>
              <a:rPr lang="en-IT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Relative activity of BcGalB in presence of chemicals</a:t>
            </a:r>
            <a:r>
              <a:rPr lang="en-IT" sz="12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endParaRPr sz="12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Widescreen</PresentationFormat>
  <Paragraphs>52</Paragraphs>
  <Slides>2</Slides>
  <Notes>2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tina Aulitto</dc:creator>
  <cp:lastModifiedBy>User</cp:lastModifiedBy>
  <cp:revision>2</cp:revision>
  <dcterms:created xsi:type="dcterms:W3CDTF">2020-12-28T15:06:35Z</dcterms:created>
  <dcterms:modified xsi:type="dcterms:W3CDTF">2020-12-30T10:42:05Z</dcterms:modified>
</cp:coreProperties>
</file>